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D69D5-9A1B-467A-8340-8BC4F88672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B399CB-B67A-4DC2-8A8E-12B751A917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0A073-2014-4380-9A1A-5A0EA1903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0D257B-BBF6-4ABD-AA8F-096D9EE35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E5F0DE-68E4-472E-A34A-370173B6B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949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D9E74-2119-46FF-96EB-06C7CB93DF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5A9715-7232-447F-85E9-E7E6D6DCFD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9FABA4-FD35-4C51-B86F-D65932037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35AD71-D3BC-47E5-BD16-B09601C9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F3AFD5-CC81-43A4-B80F-944D0B4F2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896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E21240-D4B2-432A-978C-BBB6583F4E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EF7845-D489-4801-9064-A5B5633CCB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33B40-E373-4829-AB52-17C8E1882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7CA8FD-D85E-459C-90A4-533C9E878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03195-5E41-4E68-B6DF-0C744D9C5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486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04BBC4-FD69-4537-BD04-188FFB15E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3F55AD-4C8D-4EF0-A8CC-410544B596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43B700-F726-4626-B658-4BE52FD4A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00A98A-0353-428A-BBD8-7A56F0FA0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3F1516-4C5F-4827-ACC1-14AE59283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81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E9744-21AA-4F06-97C2-4B319E706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A98F2F-0122-4A21-8BDF-DEBEA78F64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55C670-7600-46E0-B5A3-29DA5E39A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6B2E1-170C-4CA0-B49B-34DD2454E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735C8B-0BBD-45FD-85A2-AADCA1F4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45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666AF0-62EB-4556-98C9-52AD15DFB1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10277-9152-43E0-877B-43FB746EE0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757AF3-F7DB-44E0-8668-02DD679F36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004B2E-2215-41D4-8263-D99135A83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695218-0F41-4D29-B6DF-EA7E6F65E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415430-D9CF-4AD7-905A-37500FD31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970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F9889-506D-4C49-9FF5-063C989AA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DE161D-72BD-4696-93B9-52AFF67734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15CAD9-58C3-4A68-BDCC-624AEF01C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139C61-D7CF-4C00-B9CE-0109EEB6D3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275F0E-6816-4A04-87BC-6460AB5AAC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44F7FF-302A-42C4-A5AD-F95869461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C41C97-E36D-4A1D-BB7E-0F6A045D8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D72AEF-8459-4F33-A82D-124E36D99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7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41F524-09AC-4C65-AD4E-DC4E4C661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65D5F8-6348-4A3B-BC03-9BB1AD0C4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4E1D73-E263-45A9-A1BC-0F17E5B52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E5E088-6B49-45FC-9F4C-0A0B14CA1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256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84A40F-BD54-4CCC-82FE-E77B6F32D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1CA59C-B04B-49B4-8822-3D3087127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20E697-4D9F-41AF-B520-B1A84D790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60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CED69-B651-41B9-AF89-3D7EAFA8D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40C82-586E-4781-B4FF-99941EF5E2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DC7ED9-2CA2-41D8-9C69-C3EC407818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54EC3A-FA66-40CA-8A96-B7B589CDD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2AF66A-6A52-48DE-91D1-9AD283A77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5CC5A4-18E4-43A9-A59E-94F303DDC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540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E0969-37D6-4C57-841A-53B3A1B51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168A13-0852-4CA3-AEBC-E5CF619B53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444FA6-2735-4F67-BAA9-D81C4C6EFA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6CC0D8-32DD-4BA2-8435-9749363E8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5977B5-0FA5-43F0-92DB-5E47DF450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E28E37-80F7-4E2A-AD20-6BCC1B75E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626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DF4D72-A735-4EDA-8E42-726E8E827E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115558-ACF3-4509-B9EA-6083007C87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DD4260-0744-4AE1-902B-C3BA0EEA4D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562EC-293D-4121-AD23-01380483A0DA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DC5A49-1BC4-4C49-A2FD-513700CB21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E0FDDE-754B-4028-B3E0-BD4B1ED988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62206-FBC7-4476-BD8F-6C07F79E8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392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76400" y="1207532"/>
            <a:ext cx="2743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Young Stressed Worms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1676401" y="1576864"/>
          <a:ext cx="8839201" cy="3844458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066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69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01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269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12692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9814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u="none" strike="noStrike" dirty="0">
                          <a:effectLst/>
                        </a:rPr>
                        <a:t>Paramet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Mean 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T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difference with Young</a:t>
                      </a:r>
                      <a:r>
                        <a:rPr lang="en-US" sz="1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Untreate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an difference with Young</a:t>
                      </a:r>
                      <a:r>
                        <a:rPr lang="en-US" sz="1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Untreated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resence in plausible solutions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6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P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6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GC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5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1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1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66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74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7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752600" y="152400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2 Table </a:t>
            </a:r>
          </a:p>
        </p:txBody>
      </p:sp>
    </p:spTree>
    <p:extLst>
      <p:ext uri="{BB962C8B-B14F-4D97-AF65-F5344CB8AC3E}">
        <p14:creationId xmlns:p14="http://schemas.microsoft.com/office/powerpoint/2010/main" val="1249622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Widescreen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itsaG</dc:creator>
  <cp:lastModifiedBy>LenitsaG</cp:lastModifiedBy>
  <cp:revision>2</cp:revision>
  <dcterms:created xsi:type="dcterms:W3CDTF">2018-07-16T16:32:06Z</dcterms:created>
  <dcterms:modified xsi:type="dcterms:W3CDTF">2018-07-18T16:52:43Z</dcterms:modified>
</cp:coreProperties>
</file>